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8" r:id="rId3"/>
    <p:sldId id="258" r:id="rId4"/>
    <p:sldId id="259" r:id="rId5"/>
    <p:sldId id="260" r:id="rId6"/>
    <p:sldId id="261" r:id="rId7"/>
    <p:sldId id="262" r:id="rId8"/>
    <p:sldId id="272" r:id="rId9"/>
    <p:sldId id="274" r:id="rId10"/>
    <p:sldId id="265" r:id="rId11"/>
    <p:sldId id="273" r:id="rId12"/>
    <p:sldId id="264" r:id="rId13"/>
    <p:sldId id="266" r:id="rId14"/>
    <p:sldId id="267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muel Furse" initials="SF" lastIdx="2" clrIdx="0">
    <p:extLst>
      <p:ext uri="{19B8F6BF-5375-455C-9EA6-DF929625EA0E}">
        <p15:presenceInfo xmlns:p15="http://schemas.microsoft.com/office/powerpoint/2012/main" userId="f28accb2a0d69fc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5667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156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1756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38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3136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104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853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8653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726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34192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BD40F-F8CF-4598-819F-A4FBFFD6E320}" type="datetimeFigureOut">
              <a:rPr lang="en-GB" smtClean="0"/>
              <a:t>19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14BE-856E-48B7-BC77-C98A8FAFD4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2697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Segoe UI Semibold" panose="020B0702040204020203" pitchFamily="34" charset="0"/>
              </a:defRPr>
            </a:lvl1pPr>
          </a:lstStyle>
          <a:p>
            <a:fld id="{63EBD40F-F8CF-4598-819F-A4FBFFD6E320}" type="datetimeFigureOut">
              <a:rPr lang="en-GB" smtClean="0"/>
              <a:pPr/>
              <a:t>19/02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Segoe UI Semibold" panose="020B0702040204020203" pitchFamily="34" charset="0"/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Segoe UI Semibold" panose="020B0702040204020203" pitchFamily="34" charset="0"/>
              </a:defRPr>
            </a:lvl1pPr>
          </a:lstStyle>
          <a:p>
            <a:fld id="{0FF114BE-856E-48B7-BC77-C98A8FAFD47F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5773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Segoe UI Semibold" panose="020B0702040204020203" pitchFamily="34" charset="0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Segoe UI Semibold" panose="020B0702040204020203" pitchFamily="34" charset="0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Segoe UI Semibold" panose="020B0702040204020203" pitchFamily="34" charset="0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Segoe UI Semibold" panose="020B0702040204020203" pitchFamily="34" charset="0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Segoe UI Semibold" panose="020B0702040204020203" pitchFamily="34" charset="0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Segoe UI Semibold" panose="020B0702040204020203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baseline="30000" dirty="0" smtClean="0"/>
              <a:t>31</a:t>
            </a:r>
            <a:r>
              <a:rPr lang="en-GB" dirty="0" smtClean="0"/>
              <a:t>P NMR data</a:t>
            </a:r>
            <a:br>
              <a:rPr lang="en-GB" dirty="0" smtClean="0"/>
            </a:b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Furse &amp; Fernandez-Twinn </a:t>
            </a:r>
            <a:r>
              <a:rPr lang="en-GB" i="1" dirty="0" smtClean="0"/>
              <a:t>et al.</a:t>
            </a:r>
          </a:p>
          <a:p>
            <a:r>
              <a:rPr lang="en-GB" i="1" dirty="0" smtClean="0"/>
              <a:t>‘A platform for detailed, high throughput lipidomics surveys of a range of mouse and human tissue types at a molecular level’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906459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Placenta, human, LEAN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27205126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Placenta, human, normal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3035469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Placenta, human, OBESE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41015344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Serum, human, Pregnant, fasting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21371017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Serum, human, Pregnant, 2h </a:t>
            </a:r>
            <a:r>
              <a:rPr lang="en-GB" sz="1800" i="1" dirty="0" smtClean="0"/>
              <a:t>post prandial</a:t>
            </a:r>
            <a:endParaRPr lang="en-GB" sz="1800" i="1" dirty="0"/>
          </a:p>
        </p:txBody>
      </p:sp>
    </p:spTree>
    <p:extLst>
      <p:ext uri="{BB962C8B-B14F-4D97-AF65-F5344CB8AC3E}">
        <p14:creationId xmlns:p14="http://schemas.microsoft.com/office/powerpoint/2010/main" val="892070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1241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Kidney, mouse, lean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1160748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7791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Kidney, mouse, obese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41110093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Heart, mouse, lean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18342991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Heart, mouse, obese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5718184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Liver, mouse, lean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15427057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Liver, mouse, obese group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4042749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Serum, mouse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18171820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42" y="0"/>
            <a:ext cx="9714116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412595"/>
          </a:xfrm>
        </p:spPr>
        <p:txBody>
          <a:bodyPr>
            <a:normAutofit/>
          </a:bodyPr>
          <a:lstStyle/>
          <a:p>
            <a:r>
              <a:rPr lang="en-GB" sz="1800" dirty="0" smtClean="0"/>
              <a:t>Vastus, mouse</a:t>
            </a: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2637556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2</TotalTime>
  <Words>110</Words>
  <Application>Microsoft Office PowerPoint</Application>
  <PresentationFormat>Widescreen</PresentationFormat>
  <Paragraphs>16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7" baseType="lpstr">
      <vt:lpstr>Arial</vt:lpstr>
      <vt:lpstr>Segoe UI Semibold</vt:lpstr>
      <vt:lpstr>Office Theme</vt:lpstr>
      <vt:lpstr>31P NMR data </vt:lpstr>
      <vt:lpstr>Kidney, mouse, lean group</vt:lpstr>
      <vt:lpstr>Kidney, mouse, obese group</vt:lpstr>
      <vt:lpstr>Heart, mouse, lean group</vt:lpstr>
      <vt:lpstr>Heart, mouse, obese group</vt:lpstr>
      <vt:lpstr>Liver, mouse, lean group</vt:lpstr>
      <vt:lpstr>Liver, mouse, obese group</vt:lpstr>
      <vt:lpstr>Serum, mouse</vt:lpstr>
      <vt:lpstr>Vastus, mouse</vt:lpstr>
      <vt:lpstr>Placenta, human, LEAN group</vt:lpstr>
      <vt:lpstr>Placenta, human, normal group</vt:lpstr>
      <vt:lpstr>Placenta, human, OBESE group</vt:lpstr>
      <vt:lpstr>Serum, human, Pregnant, fasting</vt:lpstr>
      <vt:lpstr>Serum, human, Pregnant, 2h post prandial</vt:lpstr>
    </vt:vector>
  </TitlesOfParts>
  <Company>Clinical School Computing Servi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31P NMR data</dc:title>
  <dc:creator>Samuel Furse</dc:creator>
  <cp:lastModifiedBy>Samuel Furse</cp:lastModifiedBy>
  <cp:revision>31</cp:revision>
  <dcterms:created xsi:type="dcterms:W3CDTF">2019-09-30T09:56:13Z</dcterms:created>
  <dcterms:modified xsi:type="dcterms:W3CDTF">2020-02-19T08:15:58Z</dcterms:modified>
</cp:coreProperties>
</file>